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443" r:id="rId2"/>
    <p:sldId id="469" r:id="rId3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ADF6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淡色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E3FDE45-AF77-4B5C-9715-49D594BDF05E}" styleName="淡色 1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8D230F3-CF80-4859-8CE7-A43EE81993B5}" styleName="淡色 1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FD0F851-EC5A-4D38-B0AD-8093EC10F338}" styleName="淡色 1 - アクセント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C083E6E3-FA7D-4D7B-A595-EF9225AFEA82}" styleName="淡色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中間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3B4B98B0-60AC-42C2-AFA5-B58CD77FA1E5}" styleName="淡色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5374" autoAdjust="0"/>
    <p:restoredTop sz="99804" autoAdjust="0"/>
  </p:normalViewPr>
  <p:slideViewPr>
    <p:cSldViewPr snapToGrid="0" snapToObjects="1">
      <p:cViewPr varScale="1">
        <p:scale>
          <a:sx n="124" d="100"/>
          <a:sy n="124" d="100"/>
        </p:scale>
        <p:origin x="-104" y="-8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167A8-3DF8-CA4A-8BFC-2970A8E9CE82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B76C7E-0997-0546-959E-A19113F1F9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8018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30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1365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9982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1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1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247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482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95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817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4"/>
            <a:ext cx="4040188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33" y="1535114"/>
            <a:ext cx="4041775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33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5274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027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879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8" y="273050"/>
            <a:ext cx="3008313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5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8" y="1435105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2206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2"/>
            <a:ext cx="54864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42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680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F2012-0C3A-1749-9089-BF2CDA32670A}" type="datetimeFigureOut">
              <a:rPr kumimoji="1" lang="ja-JP" altLang="en-US" smtClean="0"/>
              <a:t>22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3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572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emf"/><Relationship Id="rId3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テキスト ボックス 21"/>
          <p:cNvSpPr txBox="1"/>
          <p:nvPr/>
        </p:nvSpPr>
        <p:spPr>
          <a:xfrm>
            <a:off x="473153" y="273946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Supplemental Figure 1</a:t>
            </a:r>
            <a:endParaRPr kumimoji="1" lang="ja-JP" altLang="en-US" b="1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01567" y="68304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A)</a:t>
            </a:r>
            <a:endParaRPr kumimoji="1" lang="ja-JP" altLang="en-US" b="1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6056636" y="1414565"/>
            <a:ext cx="2202846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fter the l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st procedure</a:t>
            </a:r>
          </a:p>
        </p:txBody>
      </p:sp>
      <p:graphicFrame>
        <p:nvGraphicFramePr>
          <p:cNvPr id="33" name="表 32">
            <a:extLst>
              <a:ext uri="{FF2B5EF4-FFF2-40B4-BE49-F238E27FC236}">
                <a16:creationId xmlns:a16="http://schemas.microsoft.com/office/drawing/2014/main" xmlns="" id="{F23A8846-D4A2-784F-B11E-FE538FEB57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8840209"/>
              </p:ext>
            </p:extLst>
          </p:nvPr>
        </p:nvGraphicFramePr>
        <p:xfrm>
          <a:off x="103980" y="4592195"/>
          <a:ext cx="4411318" cy="145732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46501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0740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7469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149634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val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day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month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ymptomatic</a:t>
                      </a:r>
                    </a:p>
                  </a:txBody>
                  <a:tcPr marL="171451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altLang="ja-JP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7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9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8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3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5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ymptomatic</a:t>
                      </a:r>
                    </a:p>
                  </a:txBody>
                  <a:tcPr marL="171451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3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3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4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0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5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4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8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2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</a:tbl>
          </a:graphicData>
        </a:graphic>
      </p:graphicFrame>
      <p:graphicFrame>
        <p:nvGraphicFramePr>
          <p:cNvPr id="35" name="表 34">
            <a:extLst>
              <a:ext uri="{FF2B5EF4-FFF2-40B4-BE49-F238E27FC236}">
                <a16:creationId xmlns:a16="http://schemas.microsoft.com/office/drawing/2014/main" xmlns="" id="{5123B313-EA2F-BF44-8D6D-6B8426CA6C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3979638"/>
              </p:ext>
            </p:extLst>
          </p:nvPr>
        </p:nvGraphicFramePr>
        <p:xfrm>
          <a:off x="4597637" y="4592195"/>
          <a:ext cx="4411318" cy="145732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46501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0740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7469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149634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val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day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month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ymptomatic</a:t>
                      </a:r>
                    </a:p>
                  </a:txBody>
                  <a:tcPr marL="171451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7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3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altLang="ja-JP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3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3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8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3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6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ymptomatic</a:t>
                      </a:r>
                    </a:p>
                  </a:txBody>
                  <a:tcPr marL="171451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3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3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0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8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9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3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6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8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.8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5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</a:tbl>
          </a:graphicData>
        </a:graphic>
      </p:graphicFrame>
      <p:pic>
        <p:nvPicPr>
          <p:cNvPr id="37" name="図 3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3600" y="1646498"/>
            <a:ext cx="4406900" cy="2882900"/>
          </a:xfrm>
          <a:prstGeom prst="rect">
            <a:avLst/>
          </a:prstGeom>
        </p:spPr>
      </p:pic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999496EF-26E0-E745-8573-4EDC33C4C3A7}"/>
              </a:ext>
            </a:extLst>
          </p:cNvPr>
          <p:cNvSpPr txBox="1"/>
          <p:nvPr/>
        </p:nvSpPr>
        <p:spPr>
          <a:xfrm>
            <a:off x="7578402" y="2345961"/>
            <a:ext cx="12426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symptomatic</a:t>
            </a:r>
          </a:p>
          <a:p>
            <a:r>
              <a:rPr kumimoji="1" lang="en-US" altLang="ja-JP" sz="12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mptomatic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AECB6143-1668-2F4D-B746-E2372CB3BE02}"/>
              </a:ext>
            </a:extLst>
          </p:cNvPr>
          <p:cNvSpPr txBox="1"/>
          <p:nvPr/>
        </p:nvSpPr>
        <p:spPr>
          <a:xfrm>
            <a:off x="5994119" y="3020462"/>
            <a:ext cx="23278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ong-rank P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0.002</a:t>
            </a:r>
          </a:p>
          <a:p>
            <a:pPr algn="ctr"/>
            <a:r>
              <a:rPr lang="en-US" altLang="ja-JP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justed HR 1.23, P=0.43</a:t>
            </a:r>
            <a:endParaRPr kumimoji="1" lang="en-US" altLang="ja-JP" sz="14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図 4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343" y="1646498"/>
            <a:ext cx="4406900" cy="2882900"/>
          </a:xfrm>
          <a:prstGeom prst="rect">
            <a:avLst/>
          </a:prstGeom>
        </p:spPr>
      </p:pic>
      <p:sp>
        <p:nvSpPr>
          <p:cNvPr id="46" name="テキスト ボックス 45"/>
          <p:cNvSpPr txBox="1"/>
          <p:nvPr/>
        </p:nvSpPr>
        <p:spPr>
          <a:xfrm>
            <a:off x="1482596" y="1411035"/>
            <a:ext cx="223330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fter the first procedure</a:t>
            </a:r>
            <a:endParaRPr kumimoji="1"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xmlns="" id="{30CC19E7-9F45-2A42-8F3C-CE734D8046C2}"/>
              </a:ext>
            </a:extLst>
          </p:cNvPr>
          <p:cNvSpPr txBox="1"/>
          <p:nvPr/>
        </p:nvSpPr>
        <p:spPr>
          <a:xfrm>
            <a:off x="2978955" y="1873253"/>
            <a:ext cx="12426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symptomatic</a:t>
            </a:r>
          </a:p>
          <a:p>
            <a:r>
              <a:rPr kumimoji="1" lang="en-US" altLang="ja-JP" sz="12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mptomatic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74E83AEE-31D5-0040-B203-FDF7E582C037}"/>
              </a:ext>
            </a:extLst>
          </p:cNvPr>
          <p:cNvSpPr txBox="1"/>
          <p:nvPr/>
        </p:nvSpPr>
        <p:spPr>
          <a:xfrm>
            <a:off x="1637623" y="3050838"/>
            <a:ext cx="23278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ong-rank P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0.050</a:t>
            </a:r>
          </a:p>
          <a:p>
            <a:pPr algn="ctr"/>
            <a:r>
              <a:rPr lang="en-US" altLang="ja-JP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justed HR 0.95, P=0.77</a:t>
            </a:r>
            <a:endParaRPr kumimoji="1" lang="en-US" altLang="ja-JP" sz="14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コネクタ 50"/>
          <p:cNvCxnSpPr/>
          <p:nvPr/>
        </p:nvCxnSpPr>
        <p:spPr>
          <a:xfrm flipV="1">
            <a:off x="1078918" y="1762688"/>
            <a:ext cx="0" cy="230400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 flipV="1">
            <a:off x="5544683" y="1762688"/>
            <a:ext cx="0" cy="230400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3" name="図 5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92451" y="1875165"/>
            <a:ext cx="215900" cy="419100"/>
          </a:xfrm>
          <a:prstGeom prst="rect">
            <a:avLst/>
          </a:prstGeom>
        </p:spPr>
      </p:pic>
      <p:pic>
        <p:nvPicPr>
          <p:cNvPr id="54" name="図 5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62502" y="2334918"/>
            <a:ext cx="215900" cy="419100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440D0A91-A4C3-5843-ABEB-BD34A2560C89}"/>
              </a:ext>
            </a:extLst>
          </p:cNvPr>
          <p:cNvSpPr txBox="1"/>
          <p:nvPr/>
        </p:nvSpPr>
        <p:spPr>
          <a:xfrm>
            <a:off x="1267935" y="4144877"/>
            <a:ext cx="34291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1           2          3           4           5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   6           7          8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08AF9BDE-DD04-9A4A-81F7-E656BCC72B55}"/>
              </a:ext>
            </a:extLst>
          </p:cNvPr>
          <p:cNvSpPr txBox="1"/>
          <p:nvPr/>
        </p:nvSpPr>
        <p:spPr>
          <a:xfrm>
            <a:off x="2247109" y="4323102"/>
            <a:ext cx="102143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Interval [years]</a:t>
            </a:r>
            <a:endParaRPr kumimoji="1" lang="ja-JP" altLang="en-US" sz="10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D0256A30-570F-CA49-88B4-F307288C607A}"/>
              </a:ext>
            </a:extLst>
          </p:cNvPr>
          <p:cNvSpPr txBox="1"/>
          <p:nvPr/>
        </p:nvSpPr>
        <p:spPr>
          <a:xfrm>
            <a:off x="5737205" y="4144877"/>
            <a:ext cx="34291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1           2          3           4           5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   6           7          8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823A06BE-3296-2F49-B867-86F15CDBDA7A}"/>
              </a:ext>
            </a:extLst>
          </p:cNvPr>
          <p:cNvSpPr txBox="1"/>
          <p:nvPr/>
        </p:nvSpPr>
        <p:spPr>
          <a:xfrm>
            <a:off x="6716379" y="4323102"/>
            <a:ext cx="102143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Interval [years]</a:t>
            </a:r>
            <a:endParaRPr kumimoji="1" lang="ja-JP" altLang="en-US" sz="10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B51978E8-F404-A24A-8A35-D2D81395605D}"/>
              </a:ext>
            </a:extLst>
          </p:cNvPr>
          <p:cNvSpPr txBox="1"/>
          <p:nvPr/>
        </p:nvSpPr>
        <p:spPr>
          <a:xfrm rot="16200000">
            <a:off x="-349699" y="2803536"/>
            <a:ext cx="1330814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Event  free survival</a:t>
            </a:r>
            <a:endParaRPr kumimoji="1" lang="ja-JP" altLang="en-US" sz="105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55F57255-DC86-6D45-947A-20B761B355AF}"/>
              </a:ext>
            </a:extLst>
          </p:cNvPr>
          <p:cNvSpPr txBox="1"/>
          <p:nvPr/>
        </p:nvSpPr>
        <p:spPr>
          <a:xfrm rot="16200000">
            <a:off x="4122162" y="2799923"/>
            <a:ext cx="1330814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Event free  survival</a:t>
            </a:r>
            <a:endParaRPr kumimoji="1" lang="ja-JP" altLang="en-US" sz="105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09964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/>
          <p:cNvSpPr txBox="1"/>
          <p:nvPr/>
        </p:nvSpPr>
        <p:spPr>
          <a:xfrm>
            <a:off x="601567" y="68304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B)</a:t>
            </a:r>
            <a:endParaRPr kumimoji="1" lang="ja-JP" altLang="en-US" b="1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graphicFrame>
        <p:nvGraphicFramePr>
          <p:cNvPr id="11" name="表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8796827"/>
              </p:ext>
            </p:extLst>
          </p:nvPr>
        </p:nvGraphicFramePr>
        <p:xfrm>
          <a:off x="2098426" y="4289869"/>
          <a:ext cx="4489413" cy="145893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49095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1462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8486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49974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49974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49974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49974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16224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val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day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month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6224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ymptomatic</a:t>
                      </a:r>
                    </a:p>
                  </a:txBody>
                  <a:tcPr marL="171451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6224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3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6224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4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6224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umulative incidence</a:t>
                      </a: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8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2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1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0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1511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ymptomatic</a:t>
                      </a:r>
                    </a:p>
                  </a:txBody>
                  <a:tcPr marL="171451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1511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9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9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1511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3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1511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9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4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2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5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</a:t>
                      </a:r>
                      <a:r>
                        <a:rPr lang="ja-JP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pic>
        <p:nvPicPr>
          <p:cNvPr id="12" name="図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0326" y="1238625"/>
            <a:ext cx="4406900" cy="2882900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03977845-4C01-434E-A908-A480A1E1ADF5}"/>
              </a:ext>
            </a:extLst>
          </p:cNvPr>
          <p:cNvSpPr txBox="1"/>
          <p:nvPr/>
        </p:nvSpPr>
        <p:spPr>
          <a:xfrm>
            <a:off x="3556232" y="2832274"/>
            <a:ext cx="23278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ong-rank P&lt;0.001</a:t>
            </a:r>
          </a:p>
          <a:p>
            <a:pPr algn="ctr"/>
            <a:r>
              <a:rPr lang="en-US" altLang="ja-JP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justed HR 1.05, P=0.73</a:t>
            </a:r>
            <a:endParaRPr kumimoji="1" lang="en-US" altLang="ja-JP" sz="14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DCA1ADFC-4EB4-5642-A683-E6D63EAC5592}"/>
              </a:ext>
            </a:extLst>
          </p:cNvPr>
          <p:cNvSpPr txBox="1"/>
          <p:nvPr/>
        </p:nvSpPr>
        <p:spPr>
          <a:xfrm>
            <a:off x="4721322" y="1625539"/>
            <a:ext cx="12426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symptomatic</a:t>
            </a:r>
          </a:p>
          <a:p>
            <a:r>
              <a:rPr kumimoji="1" lang="en-US" altLang="ja-JP" sz="12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mptomatic</a:t>
            </a:r>
          </a:p>
        </p:txBody>
      </p:sp>
      <p:pic>
        <p:nvPicPr>
          <p:cNvPr id="19" name="図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08500" y="1655404"/>
            <a:ext cx="215900" cy="419100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7B1FE92C-096C-A94F-9D43-2846BB9C3047}"/>
              </a:ext>
            </a:extLst>
          </p:cNvPr>
          <p:cNvSpPr txBox="1"/>
          <p:nvPr/>
        </p:nvSpPr>
        <p:spPr>
          <a:xfrm>
            <a:off x="3093462" y="3758841"/>
            <a:ext cx="34291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1           2          3           4           5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   6           7          8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3E46DB45-6B4D-D541-B69D-E78D52F4722D}"/>
              </a:ext>
            </a:extLst>
          </p:cNvPr>
          <p:cNvSpPr txBox="1"/>
          <p:nvPr/>
        </p:nvSpPr>
        <p:spPr>
          <a:xfrm>
            <a:off x="4072636" y="3937066"/>
            <a:ext cx="102143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Interval [years]</a:t>
            </a:r>
            <a:endParaRPr kumimoji="1" lang="ja-JP" altLang="en-US" sz="10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28E600DB-B7C8-AF4D-8692-E9CC606DCB3B}"/>
              </a:ext>
            </a:extLst>
          </p:cNvPr>
          <p:cNvSpPr txBox="1"/>
          <p:nvPr/>
        </p:nvSpPr>
        <p:spPr>
          <a:xfrm rot="16200000">
            <a:off x="1484368" y="2421347"/>
            <a:ext cx="139814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Cumulative incidence</a:t>
            </a:r>
            <a:endParaRPr kumimoji="1" lang="ja-JP" altLang="en-US" sz="10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07234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erception">
      <a:majorFont>
        <a:latin typeface="Century Gothic"/>
        <a:ea typeface=""/>
        <a:cs typeface=""/>
        <a:font script="Jpan" typeface="メイリオ"/>
        <a:font script="Hans" typeface="宋体"/>
        <a:font script="Hant" typeface="新細明體"/>
      </a:majorFont>
      <a:minorFont>
        <a:latin typeface="Century Gothic"/>
        <a:ea typeface=""/>
        <a:cs typeface=""/>
        <a:font script="Jpan" typeface="メイリオ"/>
        <a:font script="Hans" typeface="宋体"/>
        <a:font script="Hant" typeface="新細明體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42</TotalTime>
  <Words>361</Words>
  <Application>Microsoft Macintosh PowerPoint</Application>
  <PresentationFormat>画面に合わせる (4:3)</PresentationFormat>
  <Paragraphs>203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FCA for AF in Kyoto Graduate School of Medicine between 2004/2 and 2015/3</dc:title>
  <dc:creator>川治 徹真</dc:creator>
  <cp:lastModifiedBy>川治 徹真</cp:lastModifiedBy>
  <cp:revision>742</cp:revision>
  <cp:lastPrinted>2018-10-30T23:44:42Z</cp:lastPrinted>
  <dcterms:created xsi:type="dcterms:W3CDTF">2016-09-15T07:16:03Z</dcterms:created>
  <dcterms:modified xsi:type="dcterms:W3CDTF">2022-09-21T08:09:46Z</dcterms:modified>
</cp:coreProperties>
</file>